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376" y="-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TB'!$D$4,'Figure TB'!$H$4,'Figure TB'!$L$4,'Figure TB'!$P$4,'Figure TB'!$T$4,'Figure TB'!$X$4,'Figure TB'!$AB$4,'Figure TB'!$AF$4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3255151259302886</c:v>
                  </c:pt>
                  <c:pt idx="2">
                    <c:v>3.1272036551245912</c:v>
                  </c:pt>
                  <c:pt idx="3">
                    <c:v>3.1969287099858565</c:v>
                  </c:pt>
                  <c:pt idx="4">
                    <c:v>2.886148915065323</c:v>
                  </c:pt>
                  <c:pt idx="5">
                    <c:v>2.7998322541295479</c:v>
                  </c:pt>
                  <c:pt idx="6">
                    <c:v>2.6599612402585699</c:v>
                  </c:pt>
                  <c:pt idx="7">
                    <c:v>2.2653856176452862</c:v>
                  </c:pt>
                </c:numCache>
              </c:numRef>
            </c:plus>
            <c:minus>
              <c:numRef>
                <c:f>('Figure TB'!$D$4,'Figure TB'!$H$4,'Figure TB'!$L$4,'Figure TB'!$P$4,'Figure TB'!$T$4,'Figure TB'!$X$4,'Figure TB'!$AB$4,'Figure TB'!$AF$4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3255151259302886</c:v>
                  </c:pt>
                  <c:pt idx="2">
                    <c:v>3.1272036551245912</c:v>
                  </c:pt>
                  <c:pt idx="3">
                    <c:v>3.1969287099858565</c:v>
                  </c:pt>
                  <c:pt idx="4">
                    <c:v>2.886148915065323</c:v>
                  </c:pt>
                  <c:pt idx="5">
                    <c:v>2.7998322541295479</c:v>
                  </c:pt>
                  <c:pt idx="6">
                    <c:v>2.6599612402585699</c:v>
                  </c:pt>
                  <c:pt idx="7">
                    <c:v>2.2653856176452862</c:v>
                  </c:pt>
                </c:numCache>
              </c:numRef>
            </c:minus>
          </c:errBars>
          <c:cat>
            <c:strRef>
              <c:f>('Figure TB'!$C$2,'Figure TB'!$G$2,'Figure TB'!$K$2,'Figure TB'!$O$2,'Figure TB'!$S$2,'Figure TB'!$W$2,'Figure TB'!$AA$2,'Figure TB'!$AE$2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C$4,'Figure TB'!$G$4,'Figure TB'!$K$4,'Figure TB'!$O$4,'Figure TB'!$S$4,'Figure TB'!$W$4,'Figure TB'!$AA$4,'Figure TB'!$AE$4)</c:f>
              <c:numCache>
                <c:formatCode>###0.0</c:formatCode>
                <c:ptCount val="8"/>
                <c:pt idx="0">
                  <c:v>42.857142857142833</c:v>
                </c:pt>
                <c:pt idx="1">
                  <c:v>33.142857142857153</c:v>
                </c:pt>
                <c:pt idx="2">
                  <c:v>29.142857142857153</c:v>
                </c:pt>
                <c:pt idx="3">
                  <c:v>31.428571428571427</c:v>
                </c:pt>
                <c:pt idx="4">
                  <c:v>20</c:v>
                </c:pt>
                <c:pt idx="5">
                  <c:v>20</c:v>
                </c:pt>
                <c:pt idx="6">
                  <c:v>20</c:v>
                </c:pt>
                <c:pt idx="7">
                  <c:v>11.428571428571418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TB'!$F$4,'Figure TB'!$J$4,'Figure TB'!$N$4,'Figure TB'!$R$4,'Figure TB'!$V$4,'Figure TB'!$Z$4,'Figure TB'!$AD$4,'Figure TB'!$AH$4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7314577798611044</c:v>
                  </c:pt>
                  <c:pt idx="3">
                    <c:v>3.5613001095735335</c:v>
                  </c:pt>
                  <c:pt idx="4">
                    <c:v>3.2752954257326787</c:v>
                  </c:pt>
                  <c:pt idx="5">
                    <c:v>3.4376247386915439</c:v>
                  </c:pt>
                  <c:pt idx="6">
                    <c:v>3.2405367014047046</c:v>
                  </c:pt>
                  <c:pt idx="7">
                    <c:v>3.0948109488699376</c:v>
                  </c:pt>
                </c:numCache>
              </c:numRef>
            </c:plus>
            <c:minus>
              <c:numRef>
                <c:f>('Figure TB'!$F$4,'Figure TB'!$J$4,'Figure TB'!$N$4,'Figure TB'!$R$4,'Figure TB'!$V$4,'Figure TB'!$Z$4,'Figure TB'!$AD$4,'Figure TB'!$AH$4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7314577798611044</c:v>
                  </c:pt>
                  <c:pt idx="3">
                    <c:v>3.5613001095735335</c:v>
                  </c:pt>
                  <c:pt idx="4">
                    <c:v>3.2752954257326787</c:v>
                  </c:pt>
                  <c:pt idx="5">
                    <c:v>3.4376247386915439</c:v>
                  </c:pt>
                  <c:pt idx="6">
                    <c:v>3.2405367014047046</c:v>
                  </c:pt>
                  <c:pt idx="7">
                    <c:v>3.0948109488699376</c:v>
                  </c:pt>
                </c:numCache>
              </c:numRef>
            </c:minus>
          </c:errBars>
          <c:cat>
            <c:strRef>
              <c:f>('Figure TB'!$C$2,'Figure TB'!$G$2,'Figure TB'!$K$2,'Figure TB'!$O$2,'Figure TB'!$S$2,'Figure TB'!$W$2,'Figure TB'!$AA$2,'Figure TB'!$AE$2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E$4,'Figure TB'!$I$4,'Figure TB'!$M$4,'Figure TB'!$Q$4,'Figure TB'!$U$4,'Figure TB'!$Y$4,'Figure TB'!$AC$4,'Figure TB'!$AG$4)</c:f>
              <c:numCache>
                <c:formatCode>###0.0</c:formatCode>
                <c:ptCount val="8"/>
                <c:pt idx="0">
                  <c:v>25.233644859813083</c:v>
                </c:pt>
                <c:pt idx="1">
                  <c:v>23.364485981308423</c:v>
                </c:pt>
                <c:pt idx="2">
                  <c:v>21.495327102803721</c:v>
                </c:pt>
                <c:pt idx="3">
                  <c:v>18.691588785046743</c:v>
                </c:pt>
                <c:pt idx="4">
                  <c:v>14.953271028037383</c:v>
                </c:pt>
                <c:pt idx="5">
                  <c:v>16.822429906542034</c:v>
                </c:pt>
                <c:pt idx="6">
                  <c:v>14.953271028037383</c:v>
                </c:pt>
                <c:pt idx="7">
                  <c:v>13.084112149532711</c:v>
                </c:pt>
              </c:numCache>
            </c:numRef>
          </c:val>
        </c:ser>
        <c:axId val="186285440"/>
        <c:axId val="186287232"/>
      </c:barChart>
      <c:catAx>
        <c:axId val="186285440"/>
        <c:scaling>
          <c:orientation val="minMax"/>
        </c:scaling>
        <c:axPos val="b"/>
        <c:numFmt formatCode="General" sourceLinked="1"/>
        <c:tickLblPos val="nextTo"/>
        <c:crossAx val="186287232"/>
        <c:crosses val="autoZero"/>
        <c:auto val="1"/>
        <c:lblAlgn val="ctr"/>
        <c:lblOffset val="100"/>
      </c:catAx>
      <c:valAx>
        <c:axId val="186287232"/>
        <c:scaling>
          <c:orientation val="minMax"/>
          <c:max val="50"/>
        </c:scaling>
        <c:axPos val="l"/>
        <c:majorGridlines/>
        <c:title>
          <c:tx>
            <c:rich>
              <a:bodyPr rot="-5400000" vert="horz"/>
              <a:lstStyle/>
              <a:p>
                <a:pPr algn="ctr" rtl="0"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6285440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 Light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TB'!$D$9,'Figure TB'!$H$9,'Figure TB'!$L$9,'Figure TB'!$P$9,'Figure TB'!$T$9,'Figure TB'!$X$9,'Figure TB'!$AB$9,'Figure TB'!$AF$9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3349144409311142</c:v>
                  </c:pt>
                  <c:pt idx="2">
                    <c:v>3.1272036551245912</c:v>
                  </c:pt>
                  <c:pt idx="3">
                    <c:v>3.1969287099858565</c:v>
                  </c:pt>
                  <c:pt idx="4">
                    <c:v>2.9333190271920002</c:v>
                  </c:pt>
                  <c:pt idx="5">
                    <c:v>2.9095226321517109</c:v>
                  </c:pt>
                  <c:pt idx="6">
                    <c:v>2.6857060196302385</c:v>
                  </c:pt>
                  <c:pt idx="7">
                    <c:v>2.4727780332645408</c:v>
                  </c:pt>
                </c:numCache>
              </c:numRef>
            </c:plus>
            <c:minus>
              <c:numRef>
                <c:f>('Figure TB'!$D$9,'Figure TB'!$H$9,'Figure TB'!$L$9,'Figure TB'!$P$9,'Figure TB'!$T$9,'Figure TB'!$X$9,'Figure TB'!$AB$9,'Figure TB'!$AF$9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3349144409311142</c:v>
                  </c:pt>
                  <c:pt idx="2">
                    <c:v>3.1272036551245912</c:v>
                  </c:pt>
                  <c:pt idx="3">
                    <c:v>3.1969287099858565</c:v>
                  </c:pt>
                  <c:pt idx="4">
                    <c:v>2.9333190271920002</c:v>
                  </c:pt>
                  <c:pt idx="5">
                    <c:v>2.9095226321517109</c:v>
                  </c:pt>
                  <c:pt idx="6">
                    <c:v>2.6857060196302385</c:v>
                  </c:pt>
                  <c:pt idx="7">
                    <c:v>2.4727780332645408</c:v>
                  </c:pt>
                </c:numCache>
              </c:numRef>
            </c:minus>
          </c:errBars>
          <c:cat>
            <c:strRef>
              <c:f>('Figure TB'!$C$2,'Figure TB'!$G$2,'Figure TB'!$K$2,'Figure TB'!$O$2,'Figure TB'!$S$2,'Figure TB'!$W$2,'Figure TB'!$AA$2,'Figure TB'!$AE$2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C$9,'Figure TB'!$G$9,'Figure TB'!$K$9,'Figure TB'!$O$9,'Figure TB'!$S$9,'Figure TB'!$W$9,'Figure TB'!$AA$9,'Figure TB'!$AE$9)</c:f>
              <c:numCache>
                <c:formatCode>###0.0</c:formatCode>
                <c:ptCount val="8"/>
                <c:pt idx="0">
                  <c:v>42.857142857142833</c:v>
                </c:pt>
                <c:pt idx="1">
                  <c:v>33.714285714285715</c:v>
                </c:pt>
                <c:pt idx="2">
                  <c:v>29.142857142857153</c:v>
                </c:pt>
                <c:pt idx="3">
                  <c:v>31.428571428571427</c:v>
                </c:pt>
                <c:pt idx="4">
                  <c:v>20.571428571428573</c:v>
                </c:pt>
                <c:pt idx="5">
                  <c:v>22.857142857142847</c:v>
                </c:pt>
                <c:pt idx="6">
                  <c:v>20.571428571428573</c:v>
                </c:pt>
                <c:pt idx="7">
                  <c:v>14.285714285714286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TB'!$F$9,'Figure TB'!$J$9,'Figure TB'!$N$9,'Figure TB'!$R$9,'Figure TB'!$V$9,'Figure TB'!$Z$9,'Figure TB'!$AD$9,'Figure TB'!$AH$9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7314577798611044</c:v>
                  </c:pt>
                  <c:pt idx="3">
                    <c:v>3.8635236806509923</c:v>
                  </c:pt>
                  <c:pt idx="4">
                    <c:v>3.6758762718016733</c:v>
                  </c:pt>
                  <c:pt idx="5">
                    <c:v>3.5613096895257867</c:v>
                  </c:pt>
                  <c:pt idx="6">
                    <c:v>3.2405367014047046</c:v>
                  </c:pt>
                  <c:pt idx="7">
                    <c:v>3.1657844579630452</c:v>
                  </c:pt>
                </c:numCache>
              </c:numRef>
            </c:plus>
            <c:minus>
              <c:numRef>
                <c:f>('Figure TB'!$F$9,'Figure TB'!$J$9,'Figure TB'!$N$9,'Figure TB'!$R$9,'Figure TB'!$V$9,'Figure TB'!$Z$9,'Figure TB'!$AD$9,'Figure TB'!$AH$9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7314577798611044</c:v>
                  </c:pt>
                  <c:pt idx="3">
                    <c:v>3.8635236806509923</c:v>
                  </c:pt>
                  <c:pt idx="4">
                    <c:v>3.6758762718016733</c:v>
                  </c:pt>
                  <c:pt idx="5">
                    <c:v>3.5613096895257867</c:v>
                  </c:pt>
                  <c:pt idx="6">
                    <c:v>3.2405367014047046</c:v>
                  </c:pt>
                  <c:pt idx="7">
                    <c:v>3.1657844579630452</c:v>
                  </c:pt>
                </c:numCache>
              </c:numRef>
            </c:minus>
          </c:errBars>
          <c:cat>
            <c:strRef>
              <c:f>('Figure TB'!$C$2,'Figure TB'!$G$2,'Figure TB'!$K$2,'Figure TB'!$O$2,'Figure TB'!$S$2,'Figure TB'!$W$2,'Figure TB'!$AA$2,'Figure TB'!$AE$2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E$9,'Figure TB'!$I$9,'Figure TB'!$M$9,'Figure TB'!$Q$9,'Figure TB'!$U$9,'Figure TB'!$Y$9,'Figure TB'!$AC$9,'Figure TB'!$AG$9)</c:f>
              <c:numCache>
                <c:formatCode>###0.0</c:formatCode>
                <c:ptCount val="8"/>
                <c:pt idx="0">
                  <c:v>25.233644859813083</c:v>
                </c:pt>
                <c:pt idx="1">
                  <c:v>23.364485981308423</c:v>
                </c:pt>
                <c:pt idx="2">
                  <c:v>21.495327102803721</c:v>
                </c:pt>
                <c:pt idx="3">
                  <c:v>22.429906542056074</c:v>
                </c:pt>
                <c:pt idx="4">
                  <c:v>19.626168224299079</c:v>
                </c:pt>
                <c:pt idx="5">
                  <c:v>18.691588785046743</c:v>
                </c:pt>
                <c:pt idx="6">
                  <c:v>14.953271028037383</c:v>
                </c:pt>
                <c:pt idx="7">
                  <c:v>14.018691588785046</c:v>
                </c:pt>
              </c:numCache>
            </c:numRef>
          </c:val>
        </c:ser>
        <c:axId val="187038336"/>
        <c:axId val="187138432"/>
      </c:barChart>
      <c:catAx>
        <c:axId val="187038336"/>
        <c:scaling>
          <c:orientation val="minMax"/>
        </c:scaling>
        <c:axPos val="b"/>
        <c:numFmt formatCode="General" sourceLinked="1"/>
        <c:tickLblPos val="nextTo"/>
        <c:crossAx val="187138432"/>
        <c:crosses val="autoZero"/>
        <c:auto val="1"/>
        <c:lblAlgn val="ctr"/>
        <c:lblOffset val="100"/>
      </c:catAx>
      <c:valAx>
        <c:axId val="187138432"/>
        <c:scaling>
          <c:orientation val="minMax"/>
          <c:max val="5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7038336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 Light" pitchFamily="34" charset="0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TB'!$D$14,'Figure TB'!$H$14,'Figure TB'!$L$14,'Figure TB'!$P$14,'Figure TB'!$T$14,'Figure TB'!$X$14,'Figure TB'!$AB$14,'Figure TB'!$AF$14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3713116189861787</c:v>
                  </c:pt>
                  <c:pt idx="2">
                    <c:v>3.1727221826060159</c:v>
                  </c:pt>
                  <c:pt idx="3">
                    <c:v>3.2836382360935152</c:v>
                  </c:pt>
                  <c:pt idx="4">
                    <c:v>3.1424697979668488</c:v>
                  </c:pt>
                  <c:pt idx="5">
                    <c:v>2.9775903626427556</c:v>
                  </c:pt>
                  <c:pt idx="6">
                    <c:v>2.8191807292594531</c:v>
                  </c:pt>
                  <c:pt idx="7">
                    <c:v>2.6159108578123154</c:v>
                  </c:pt>
                </c:numCache>
              </c:numRef>
            </c:plus>
            <c:minus>
              <c:numRef>
                <c:f>('Figure TB'!$D$14,'Figure TB'!$H$14,'Figure TB'!$L$14,'Figure TB'!$P$14,'Figure TB'!$T$14,'Figure TB'!$X$14,'Figure TB'!$AB$14,'Figure TB'!$AF$14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3713116189861787</c:v>
                  </c:pt>
                  <c:pt idx="2">
                    <c:v>3.1727221826060159</c:v>
                  </c:pt>
                  <c:pt idx="3">
                    <c:v>3.2836382360935152</c:v>
                  </c:pt>
                  <c:pt idx="4">
                    <c:v>3.1424697979668488</c:v>
                  </c:pt>
                  <c:pt idx="5">
                    <c:v>2.9775903626427556</c:v>
                  </c:pt>
                  <c:pt idx="6">
                    <c:v>2.8191807292594531</c:v>
                  </c:pt>
                  <c:pt idx="7">
                    <c:v>2.6159108578123154</c:v>
                  </c:pt>
                </c:numCache>
              </c:numRef>
            </c:minus>
          </c:errBars>
          <c:cat>
            <c:strRef>
              <c:f>('Figure TB'!$C$12,'Figure TB'!$G$12,'Figure TB'!$K$12,'Figure TB'!$O$12,'Figure TB'!$S$12,'Figure TB'!$W$12,'Figure TB'!$AA$12,'Figure TB'!$AE$12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C$14,'Figure TB'!$G$14,'Figure TB'!$K$14,'Figure TB'!$O$14,'Figure TB'!$S$14,'Figure TB'!$W$14,'Figure TB'!$AA$14,'Figure TB'!$AE$14)</c:f>
              <c:numCache>
                <c:formatCode>###0.0</c:formatCode>
                <c:ptCount val="8"/>
                <c:pt idx="0">
                  <c:v>42.857142857142833</c:v>
                </c:pt>
                <c:pt idx="1">
                  <c:v>34.857142857142833</c:v>
                </c:pt>
                <c:pt idx="2">
                  <c:v>30.285714285714263</c:v>
                </c:pt>
                <c:pt idx="3">
                  <c:v>33.714285714285715</c:v>
                </c:pt>
                <c:pt idx="4">
                  <c:v>24</c:v>
                </c:pt>
                <c:pt idx="5">
                  <c:v>24</c:v>
                </c:pt>
                <c:pt idx="6">
                  <c:v>22.857142857142847</c:v>
                </c:pt>
                <c:pt idx="7">
                  <c:v>16.571428571428573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TB'!$F$14,'Figure TB'!$J$14,'Figure TB'!$N$14,'Figure TB'!$R$14,'Figure TB'!$V$14,'Figure TB'!$Z$14,'Figure TB'!$AD$14,'Figure TB'!$AH$14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8089986543450487</c:v>
                  </c:pt>
                  <c:pt idx="3">
                    <c:v>3.8664185690981867</c:v>
                  </c:pt>
                  <c:pt idx="4">
                    <c:v>3.7297689448683342</c:v>
                  </c:pt>
                  <c:pt idx="5">
                    <c:v>3.6271431327287837</c:v>
                  </c:pt>
                  <c:pt idx="6">
                    <c:v>3.3183435564823083</c:v>
                  </c:pt>
                  <c:pt idx="7">
                    <c:v>3.2405367014047046</c:v>
                  </c:pt>
                </c:numCache>
              </c:numRef>
            </c:plus>
            <c:minus>
              <c:numRef>
                <c:f>('Figure TB'!$F$14,'Figure TB'!$J$14,'Figure TB'!$N$14,'Figure TB'!$R$14,'Figure TB'!$V$14,'Figure TB'!$Z$14,'Figure TB'!$AD$14,'Figure TB'!$AH$14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8089986543450487</c:v>
                  </c:pt>
                  <c:pt idx="3">
                    <c:v>3.8664185690981867</c:v>
                  </c:pt>
                  <c:pt idx="4">
                    <c:v>3.7297689448683342</c:v>
                  </c:pt>
                  <c:pt idx="5">
                    <c:v>3.6271431327287837</c:v>
                  </c:pt>
                  <c:pt idx="6">
                    <c:v>3.3183435564823083</c:v>
                  </c:pt>
                  <c:pt idx="7">
                    <c:v>3.2405367014047046</c:v>
                  </c:pt>
                </c:numCache>
              </c:numRef>
            </c:minus>
          </c:errBars>
          <c:cat>
            <c:strRef>
              <c:f>('Figure TB'!$C$12,'Figure TB'!$G$12,'Figure TB'!$K$12,'Figure TB'!$O$12,'Figure TB'!$S$12,'Figure TB'!$W$12,'Figure TB'!$AA$12,'Figure TB'!$AE$12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E$14,'Figure TB'!$I$14,'Figure TB'!$M$14,'Figure TB'!$Q$14,'Figure TB'!$U$14,'Figure TB'!$Y$14,'Figure TB'!$AC$14,'Figure TB'!$AG$14)</c:f>
              <c:numCache>
                <c:formatCode>###0.0</c:formatCode>
                <c:ptCount val="8"/>
                <c:pt idx="0">
                  <c:v>25.233644859813083</c:v>
                </c:pt>
                <c:pt idx="1">
                  <c:v>23.364485981308423</c:v>
                </c:pt>
                <c:pt idx="2">
                  <c:v>22.429906542056074</c:v>
                </c:pt>
                <c:pt idx="3">
                  <c:v>23.364485981308423</c:v>
                </c:pt>
                <c:pt idx="4">
                  <c:v>21.495327102803721</c:v>
                </c:pt>
                <c:pt idx="5">
                  <c:v>19.626168224299079</c:v>
                </c:pt>
                <c:pt idx="6">
                  <c:v>15.88785046728972</c:v>
                </c:pt>
                <c:pt idx="7">
                  <c:v>14.953271028037383</c:v>
                </c:pt>
              </c:numCache>
            </c:numRef>
          </c:val>
        </c:ser>
        <c:axId val="187159680"/>
        <c:axId val="187161216"/>
      </c:barChart>
      <c:catAx>
        <c:axId val="187159680"/>
        <c:scaling>
          <c:orientation val="minMax"/>
        </c:scaling>
        <c:axPos val="b"/>
        <c:tickLblPos val="nextTo"/>
        <c:crossAx val="187161216"/>
        <c:crosses val="autoZero"/>
        <c:auto val="1"/>
        <c:lblAlgn val="ctr"/>
        <c:lblOffset val="100"/>
      </c:catAx>
      <c:valAx>
        <c:axId val="187161216"/>
        <c:scaling>
          <c:orientation val="minMax"/>
          <c:max val="5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n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7159680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 Light" pitchFamily="34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TB'!$D$19,'Figure TB'!$H$19,'Figure TB'!$L$19,'Figure TB'!$P$19,'Figure TB'!$T$19,'Figure TB'!$X$19,'Figure TB'!$AB$19,'Figure TB'!$AF$19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2904588403808477</c:v>
                  </c:pt>
                  <c:pt idx="2">
                    <c:v>3.1727221826060159</c:v>
                  </c:pt>
                  <c:pt idx="3">
                    <c:v>3.3051296450273546</c:v>
                  </c:pt>
                  <c:pt idx="4">
                    <c:v>3.2598147696290551</c:v>
                  </c:pt>
                  <c:pt idx="5">
                    <c:v>3.0082880942972197</c:v>
                  </c:pt>
                  <c:pt idx="6">
                    <c:v>2.8191807292594531</c:v>
                  </c:pt>
                  <c:pt idx="7">
                    <c:v>2.7337724849670182</c:v>
                  </c:pt>
                </c:numCache>
              </c:numRef>
            </c:plus>
            <c:minus>
              <c:numRef>
                <c:f>('Figure TB'!$D$19,'Figure TB'!$H$19,'Figure TB'!$L$19,'Figure TB'!$P$19,'Figure TB'!$T$19,'Figure TB'!$X$19,'Figure TB'!$AB$19,'Figure TB'!$AF$19)</c:f>
                <c:numCache>
                  <c:formatCode>General</c:formatCode>
                  <c:ptCount val="8"/>
                  <c:pt idx="0">
                    <c:v>3.4480645361465392</c:v>
                  </c:pt>
                  <c:pt idx="1">
                    <c:v>3.2904588403808477</c:v>
                  </c:pt>
                  <c:pt idx="2">
                    <c:v>3.1727221826060159</c:v>
                  </c:pt>
                  <c:pt idx="3">
                    <c:v>3.3051296450273546</c:v>
                  </c:pt>
                  <c:pt idx="4">
                    <c:v>3.2598147696290551</c:v>
                  </c:pt>
                  <c:pt idx="5">
                    <c:v>3.0082880942972197</c:v>
                  </c:pt>
                  <c:pt idx="6">
                    <c:v>2.8191807292594531</c:v>
                  </c:pt>
                  <c:pt idx="7">
                    <c:v>2.7337724849670182</c:v>
                  </c:pt>
                </c:numCache>
              </c:numRef>
            </c:minus>
          </c:errBars>
          <c:cat>
            <c:strRef>
              <c:f>('Figure TB'!$C$17,'Figure TB'!$G$17,'Figure TB'!$K$17,'Figure TB'!$O$17,'Figure TB'!$S$17,'Figure TB'!$W$17,'Figure TB'!$AA$17,'Figure TB'!$AE$17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C$19,'Figure TB'!$G$19,'Figure TB'!$K$19,'Figure TB'!$O$19,'Figure TB'!$S$19,'Figure TB'!$W$19,'Figure TB'!$AA$19,'Figure TB'!$AE$19)</c:f>
              <c:numCache>
                <c:formatCode>###0.0</c:formatCode>
                <c:ptCount val="8"/>
                <c:pt idx="0">
                  <c:v>42.857142857142833</c:v>
                </c:pt>
                <c:pt idx="1">
                  <c:v>37.714285714285715</c:v>
                </c:pt>
                <c:pt idx="2">
                  <c:v>30.285714285714263</c:v>
                </c:pt>
                <c:pt idx="3">
                  <c:v>35.428571428571459</c:v>
                </c:pt>
                <c:pt idx="4">
                  <c:v>26.285714285714263</c:v>
                </c:pt>
                <c:pt idx="5">
                  <c:v>28.571428571428573</c:v>
                </c:pt>
                <c:pt idx="6">
                  <c:v>22.857142857142847</c:v>
                </c:pt>
                <c:pt idx="7">
                  <c:v>19.428571428571427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TB'!$F$19,'Figure TB'!$J$19,'Figure TB'!$N$19,'Figure TB'!$R$19,'Figure TB'!$V$19,'Figure TB'!$Z$19,'Figure TB'!$AD$19,'Figure TB'!$AH$19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8089986543450487</c:v>
                  </c:pt>
                  <c:pt idx="3">
                    <c:v>3.920753883480208</c:v>
                  </c:pt>
                  <c:pt idx="4">
                    <c:v>3.794507534137658</c:v>
                  </c:pt>
                  <c:pt idx="5">
                    <c:v>3.6897049840233422</c:v>
                  </c:pt>
                  <c:pt idx="6">
                    <c:v>3.7187280355662677</c:v>
                  </c:pt>
                  <c:pt idx="7">
                    <c:v>3.4770395727401699</c:v>
                  </c:pt>
                </c:numCache>
              </c:numRef>
            </c:plus>
            <c:minus>
              <c:numRef>
                <c:f>('Figure TB'!$F$19,'Figure TB'!$J$19,'Figure TB'!$N$19,'Figure TB'!$R$19,'Figure TB'!$V$19,'Figure TB'!$Z$19,'Figure TB'!$AD$19,'Figure TB'!$AH$19)</c:f>
                <c:numCache>
                  <c:formatCode>General</c:formatCode>
                  <c:ptCount val="8"/>
                  <c:pt idx="0">
                    <c:v>4.2108836262680756</c:v>
                  </c:pt>
                  <c:pt idx="1">
                    <c:v>3.8792541685457991</c:v>
                  </c:pt>
                  <c:pt idx="2">
                    <c:v>3.8089986543450487</c:v>
                  </c:pt>
                  <c:pt idx="3">
                    <c:v>3.920753883480208</c:v>
                  </c:pt>
                  <c:pt idx="4">
                    <c:v>3.794507534137658</c:v>
                  </c:pt>
                  <c:pt idx="5">
                    <c:v>3.6897049840233422</c:v>
                  </c:pt>
                  <c:pt idx="6">
                    <c:v>3.7187280355662677</c:v>
                  </c:pt>
                  <c:pt idx="7">
                    <c:v>3.4770395727401699</c:v>
                  </c:pt>
                </c:numCache>
              </c:numRef>
            </c:minus>
          </c:errBars>
          <c:cat>
            <c:strRef>
              <c:f>('Figure TB'!$C$17,'Figure TB'!$G$17,'Figure TB'!$K$17,'Figure TB'!$O$17,'Figure TB'!$S$17,'Figure TB'!$W$17,'Figure TB'!$AA$17,'Figure TB'!$AE$17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TB'!$E$19,'Figure TB'!$I$19,'Figure TB'!$M$19,'Figure TB'!$Q$19,'Figure TB'!$U$19,'Figure TB'!$Y$19,'Figure TB'!$AC$19,'Figure TB'!$AG$19)</c:f>
              <c:numCache>
                <c:formatCode>###0.0</c:formatCode>
                <c:ptCount val="8"/>
                <c:pt idx="0">
                  <c:v>25.233644859813083</c:v>
                </c:pt>
                <c:pt idx="1">
                  <c:v>23.364485981308423</c:v>
                </c:pt>
                <c:pt idx="2">
                  <c:v>22.429906542056074</c:v>
                </c:pt>
                <c:pt idx="3">
                  <c:v>24.299065420560748</c:v>
                </c:pt>
                <c:pt idx="4">
                  <c:v>22.429906542056074</c:v>
                </c:pt>
                <c:pt idx="5">
                  <c:v>21.495327102803721</c:v>
                </c:pt>
                <c:pt idx="6">
                  <c:v>20.560747663551389</c:v>
                </c:pt>
                <c:pt idx="7">
                  <c:v>17.757009345794387</c:v>
                </c:pt>
              </c:numCache>
            </c:numRef>
          </c:val>
        </c:ser>
        <c:axId val="187190656"/>
        <c:axId val="187208832"/>
      </c:barChart>
      <c:catAx>
        <c:axId val="187190656"/>
        <c:scaling>
          <c:orientation val="minMax"/>
        </c:scaling>
        <c:axPos val="b"/>
        <c:tickLblPos val="nextTo"/>
        <c:crossAx val="187208832"/>
        <c:crosses val="autoZero"/>
        <c:auto val="1"/>
        <c:lblAlgn val="ctr"/>
        <c:lblOffset val="100"/>
      </c:catAx>
      <c:valAx>
        <c:axId val="187208832"/>
        <c:scaling>
          <c:orientation val="minMax"/>
          <c:max val="5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7190656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 Light" pitchFamily="34" charset="0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959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5216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24541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5175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44656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90079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0022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87530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3020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27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50362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3397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993415714"/>
              </p:ext>
            </p:extLst>
          </p:nvPr>
        </p:nvGraphicFramePr>
        <p:xfrm>
          <a:off x="101380" y="561975"/>
          <a:ext cx="458424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436975704"/>
              </p:ext>
            </p:extLst>
          </p:nvPr>
        </p:nvGraphicFramePr>
        <p:xfrm>
          <a:off x="4526869" y="561975"/>
          <a:ext cx="465364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6670501"/>
              </p:ext>
            </p:extLst>
          </p:nvPr>
        </p:nvGraphicFramePr>
        <p:xfrm>
          <a:off x="120430" y="3533775"/>
          <a:ext cx="458424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786028752"/>
              </p:ext>
            </p:extLst>
          </p:nvPr>
        </p:nvGraphicFramePr>
        <p:xfrm>
          <a:off x="4526869" y="3552825"/>
          <a:ext cx="465364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815758" y="683696"/>
            <a:ext cx="611065" cy="246221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1000" dirty="0" smtClean="0">
                <a:latin typeface="Myriad Pro" pitchFamily="34" charset="0"/>
                <a:cs typeface="Arial" panose="020B0604020202020204" pitchFamily="34" charset="0"/>
              </a:rPr>
              <a:t>(a) 90%</a:t>
            </a:r>
            <a:endParaRPr lang="en-US" sz="1000" dirty="0">
              <a:latin typeface="Myriad Pro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244631" y="687384"/>
            <a:ext cx="620683" cy="246221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1000" dirty="0" smtClean="0">
                <a:latin typeface="Myriad Pro" pitchFamily="34" charset="0"/>
                <a:cs typeface="Arial" panose="020B0604020202020204" pitchFamily="34" charset="0"/>
              </a:rPr>
              <a:t>(b) 80%</a:t>
            </a:r>
            <a:endParaRPr lang="en-US" sz="1000" dirty="0">
              <a:latin typeface="Myriad Pro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840827" y="3659030"/>
            <a:ext cx="601447" cy="246221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1000" dirty="0" smtClean="0">
                <a:latin typeface="Myriad Pro" pitchFamily="34" charset="0"/>
                <a:cs typeface="Arial" panose="020B0604020202020204" pitchFamily="34" charset="0"/>
              </a:rPr>
              <a:t>(c) 70%</a:t>
            </a:r>
            <a:endParaRPr lang="en-US" sz="1000" dirty="0">
              <a:latin typeface="Myriad Pro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242975" y="3679264"/>
            <a:ext cx="620683" cy="246221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1000" dirty="0" smtClean="0">
                <a:latin typeface="Myriad Pro" pitchFamily="34" charset="0"/>
                <a:cs typeface="Arial" panose="020B0604020202020204" pitchFamily="34" charset="0"/>
              </a:rPr>
              <a:t>(d) 60%</a:t>
            </a:r>
            <a:endParaRPr lang="en-US" sz="1000" dirty="0">
              <a:latin typeface="Myriad Pro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44951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4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Erasmus 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. Fuady</dc:creator>
  <cp:lastModifiedBy>Fuady</cp:lastModifiedBy>
  <cp:revision>24</cp:revision>
  <dcterms:created xsi:type="dcterms:W3CDTF">2018-05-17T11:37:03Z</dcterms:created>
  <dcterms:modified xsi:type="dcterms:W3CDTF">2018-12-20T22:55:36Z</dcterms:modified>
</cp:coreProperties>
</file>